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5"/>
  </p:notesMasterIdLst>
  <p:handoutMasterIdLst>
    <p:handoutMasterId r:id="rId6"/>
  </p:handoutMasterIdLst>
  <p:sldIdLst>
    <p:sldId id="313" r:id="rId2"/>
    <p:sldId id="316" r:id="rId3"/>
    <p:sldId id="317" r:id="rId4"/>
  </p:sldIdLst>
  <p:sldSz cx="11376025" cy="9720263"/>
  <p:notesSz cx="9866313" cy="67357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yra Villareal" initials="" lastIdx="8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FF"/>
    <a:srgbClr val="00FFF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86" autoAdjust="0"/>
    <p:restoredTop sz="94434" autoAdjust="0"/>
  </p:normalViewPr>
  <p:slideViewPr>
    <p:cSldViewPr snapToGrid="0">
      <p:cViewPr>
        <p:scale>
          <a:sx n="100" d="100"/>
          <a:sy n="100" d="100"/>
        </p:scale>
        <p:origin x="298" y="-25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6255" cy="33814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5587733" y="0"/>
            <a:ext cx="4276254" cy="33814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409168-C0D2-4D6E-9C4A-0E0191DD379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1" y="6397620"/>
            <a:ext cx="4276255" cy="33814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5587733" y="6397620"/>
            <a:ext cx="4276254" cy="33814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D2696A-DC8B-41EB-BF0F-E550E0D86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07211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5" y="0"/>
            <a:ext cx="4276255" cy="338143"/>
          </a:xfrm>
          <a:prstGeom prst="rect">
            <a:avLst/>
          </a:prstGeom>
        </p:spPr>
        <p:txBody>
          <a:bodyPr vert="horz" lIns="91433" tIns="45716" rIns="91433" bIns="457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587733" y="0"/>
            <a:ext cx="4276254" cy="338143"/>
          </a:xfrm>
          <a:prstGeom prst="rect">
            <a:avLst/>
          </a:prstGeom>
        </p:spPr>
        <p:txBody>
          <a:bodyPr vert="horz" lIns="91433" tIns="45716" rIns="91433" bIns="45716" rtlCol="0"/>
          <a:lstStyle>
            <a:lvl1pPr algn="r">
              <a:defRPr sz="1200"/>
            </a:lvl1pPr>
          </a:lstStyle>
          <a:p>
            <a:fld id="{6C3AAEEC-AD31-421C-AC41-E02AB32BCEF2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603625" y="841375"/>
            <a:ext cx="2659063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3" tIns="45716" rIns="91433" bIns="45716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985936" y="3241620"/>
            <a:ext cx="7894446" cy="2652037"/>
          </a:xfrm>
          <a:prstGeom prst="rect">
            <a:avLst/>
          </a:prstGeom>
        </p:spPr>
        <p:txBody>
          <a:bodyPr vert="horz" lIns="91433" tIns="45716" rIns="91433" bIns="45716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5" y="6397621"/>
            <a:ext cx="4276255" cy="338143"/>
          </a:xfrm>
          <a:prstGeom prst="rect">
            <a:avLst/>
          </a:prstGeom>
        </p:spPr>
        <p:txBody>
          <a:bodyPr vert="horz" lIns="91433" tIns="45716" rIns="91433" bIns="457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587733" y="6397621"/>
            <a:ext cx="4276254" cy="338143"/>
          </a:xfrm>
          <a:prstGeom prst="rect">
            <a:avLst/>
          </a:prstGeom>
        </p:spPr>
        <p:txBody>
          <a:bodyPr vert="horz" lIns="91433" tIns="45716" rIns="91433" bIns="45716" rtlCol="0" anchor="b"/>
          <a:lstStyle>
            <a:lvl1pPr algn="r">
              <a:defRPr sz="1200"/>
            </a:lvl1pPr>
          </a:lstStyle>
          <a:p>
            <a:fld id="{537255D7-70CF-4DE4-A40C-7D86BB178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05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3202" y="1590794"/>
            <a:ext cx="9669621" cy="3384092"/>
          </a:xfrm>
        </p:spPr>
        <p:txBody>
          <a:bodyPr anchor="b"/>
          <a:lstStyle>
            <a:lvl1pPr algn="ctr">
              <a:defRPr sz="746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22003" y="5105389"/>
            <a:ext cx="8532019" cy="2346813"/>
          </a:xfrm>
        </p:spPr>
        <p:txBody>
          <a:bodyPr/>
          <a:lstStyle>
            <a:lvl1pPr marL="0" indent="0" algn="ctr">
              <a:buNone/>
              <a:defRPr sz="2986"/>
            </a:lvl1pPr>
            <a:lvl2pPr marL="568803" indent="0" algn="ctr">
              <a:buNone/>
              <a:defRPr sz="2488"/>
            </a:lvl2pPr>
            <a:lvl3pPr marL="1137605" indent="0" algn="ctr">
              <a:buNone/>
              <a:defRPr sz="2239"/>
            </a:lvl3pPr>
            <a:lvl4pPr marL="1706408" indent="0" algn="ctr">
              <a:buNone/>
              <a:defRPr sz="1991"/>
            </a:lvl4pPr>
            <a:lvl5pPr marL="2275210" indent="0" algn="ctr">
              <a:buNone/>
              <a:defRPr sz="1991"/>
            </a:lvl5pPr>
            <a:lvl6pPr marL="2844013" indent="0" algn="ctr">
              <a:buNone/>
              <a:defRPr sz="1991"/>
            </a:lvl6pPr>
            <a:lvl7pPr marL="3412815" indent="0" algn="ctr">
              <a:buNone/>
              <a:defRPr sz="1991"/>
            </a:lvl7pPr>
            <a:lvl8pPr marL="3981618" indent="0" algn="ctr">
              <a:buNone/>
              <a:defRPr sz="1991"/>
            </a:lvl8pPr>
            <a:lvl9pPr marL="4550420" indent="0" algn="ctr">
              <a:buNone/>
              <a:defRPr sz="1991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522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472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140969" y="517514"/>
            <a:ext cx="2452955" cy="8237474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82102" y="517514"/>
            <a:ext cx="7216666" cy="8237474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022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894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6177" y="2423318"/>
            <a:ext cx="9811822" cy="4043359"/>
          </a:xfrm>
        </p:spPr>
        <p:txBody>
          <a:bodyPr anchor="b"/>
          <a:lstStyle>
            <a:lvl1pPr>
              <a:defRPr sz="746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6177" y="6504929"/>
            <a:ext cx="9811822" cy="2126307"/>
          </a:xfrm>
        </p:spPr>
        <p:txBody>
          <a:bodyPr/>
          <a:lstStyle>
            <a:lvl1pPr marL="0" indent="0">
              <a:buNone/>
              <a:defRPr sz="2986">
                <a:solidFill>
                  <a:schemeClr val="tx1"/>
                </a:solidFill>
              </a:defRPr>
            </a:lvl1pPr>
            <a:lvl2pPr marL="568803" indent="0">
              <a:buNone/>
              <a:defRPr sz="2488">
                <a:solidFill>
                  <a:schemeClr val="tx1">
                    <a:tint val="75000"/>
                  </a:schemeClr>
                </a:solidFill>
              </a:defRPr>
            </a:lvl2pPr>
            <a:lvl3pPr marL="1137605" indent="0">
              <a:buNone/>
              <a:defRPr sz="2239">
                <a:solidFill>
                  <a:schemeClr val="tx1">
                    <a:tint val="75000"/>
                  </a:schemeClr>
                </a:solidFill>
              </a:defRPr>
            </a:lvl3pPr>
            <a:lvl4pPr marL="1706408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4pPr>
            <a:lvl5pPr marL="2275210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5pPr>
            <a:lvl6pPr marL="2844013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6pPr>
            <a:lvl7pPr marL="3412815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7pPr>
            <a:lvl8pPr marL="3981618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8pPr>
            <a:lvl9pPr marL="4550420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636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82102" y="2587570"/>
            <a:ext cx="4834811" cy="616741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59112" y="2587570"/>
            <a:ext cx="4834811" cy="616741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596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3583" y="517516"/>
            <a:ext cx="9811822" cy="18788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3585" y="2382815"/>
            <a:ext cx="4812591" cy="1167781"/>
          </a:xfrm>
        </p:spPr>
        <p:txBody>
          <a:bodyPr anchor="b"/>
          <a:lstStyle>
            <a:lvl1pPr marL="0" indent="0">
              <a:buNone/>
              <a:defRPr sz="2986" b="1"/>
            </a:lvl1pPr>
            <a:lvl2pPr marL="568803" indent="0">
              <a:buNone/>
              <a:defRPr sz="2488" b="1"/>
            </a:lvl2pPr>
            <a:lvl3pPr marL="1137605" indent="0">
              <a:buNone/>
              <a:defRPr sz="2239" b="1"/>
            </a:lvl3pPr>
            <a:lvl4pPr marL="1706408" indent="0">
              <a:buNone/>
              <a:defRPr sz="1991" b="1"/>
            </a:lvl4pPr>
            <a:lvl5pPr marL="2275210" indent="0">
              <a:buNone/>
              <a:defRPr sz="1991" b="1"/>
            </a:lvl5pPr>
            <a:lvl6pPr marL="2844013" indent="0">
              <a:buNone/>
              <a:defRPr sz="1991" b="1"/>
            </a:lvl6pPr>
            <a:lvl7pPr marL="3412815" indent="0">
              <a:buNone/>
              <a:defRPr sz="1991" b="1"/>
            </a:lvl7pPr>
            <a:lvl8pPr marL="3981618" indent="0">
              <a:buNone/>
              <a:defRPr sz="1991" b="1"/>
            </a:lvl8pPr>
            <a:lvl9pPr marL="4550420" indent="0">
              <a:buNone/>
              <a:defRPr sz="1991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3585" y="3550596"/>
            <a:ext cx="4812591" cy="5222392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759113" y="2382815"/>
            <a:ext cx="4836292" cy="1167781"/>
          </a:xfrm>
        </p:spPr>
        <p:txBody>
          <a:bodyPr anchor="b"/>
          <a:lstStyle>
            <a:lvl1pPr marL="0" indent="0">
              <a:buNone/>
              <a:defRPr sz="2986" b="1"/>
            </a:lvl1pPr>
            <a:lvl2pPr marL="568803" indent="0">
              <a:buNone/>
              <a:defRPr sz="2488" b="1"/>
            </a:lvl2pPr>
            <a:lvl3pPr marL="1137605" indent="0">
              <a:buNone/>
              <a:defRPr sz="2239" b="1"/>
            </a:lvl3pPr>
            <a:lvl4pPr marL="1706408" indent="0">
              <a:buNone/>
              <a:defRPr sz="1991" b="1"/>
            </a:lvl4pPr>
            <a:lvl5pPr marL="2275210" indent="0">
              <a:buNone/>
              <a:defRPr sz="1991" b="1"/>
            </a:lvl5pPr>
            <a:lvl6pPr marL="2844013" indent="0">
              <a:buNone/>
              <a:defRPr sz="1991" b="1"/>
            </a:lvl6pPr>
            <a:lvl7pPr marL="3412815" indent="0">
              <a:buNone/>
              <a:defRPr sz="1991" b="1"/>
            </a:lvl7pPr>
            <a:lvl8pPr marL="3981618" indent="0">
              <a:buNone/>
              <a:defRPr sz="1991" b="1"/>
            </a:lvl8pPr>
            <a:lvl9pPr marL="4550420" indent="0">
              <a:buNone/>
              <a:defRPr sz="1991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759113" y="3550596"/>
            <a:ext cx="4836292" cy="5222392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25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065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219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3584" y="648018"/>
            <a:ext cx="3669064" cy="2268061"/>
          </a:xfrm>
        </p:spPr>
        <p:txBody>
          <a:bodyPr anchor="b"/>
          <a:lstStyle>
            <a:lvl1pPr>
              <a:defRPr sz="3981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36292" y="1399540"/>
            <a:ext cx="5759113" cy="6907687"/>
          </a:xfrm>
        </p:spPr>
        <p:txBody>
          <a:bodyPr/>
          <a:lstStyle>
            <a:lvl1pPr>
              <a:defRPr sz="3981"/>
            </a:lvl1pPr>
            <a:lvl2pPr>
              <a:defRPr sz="3483"/>
            </a:lvl2pPr>
            <a:lvl3pPr>
              <a:defRPr sz="2986"/>
            </a:lvl3pPr>
            <a:lvl4pPr>
              <a:defRPr sz="2488"/>
            </a:lvl4pPr>
            <a:lvl5pPr>
              <a:defRPr sz="2488"/>
            </a:lvl5pPr>
            <a:lvl6pPr>
              <a:defRPr sz="2488"/>
            </a:lvl6pPr>
            <a:lvl7pPr>
              <a:defRPr sz="2488"/>
            </a:lvl7pPr>
            <a:lvl8pPr>
              <a:defRPr sz="2488"/>
            </a:lvl8pPr>
            <a:lvl9pPr>
              <a:defRPr sz="2488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3584" y="2916079"/>
            <a:ext cx="3669064" cy="5402397"/>
          </a:xfrm>
        </p:spPr>
        <p:txBody>
          <a:bodyPr/>
          <a:lstStyle>
            <a:lvl1pPr marL="0" indent="0">
              <a:buNone/>
              <a:defRPr sz="1991"/>
            </a:lvl1pPr>
            <a:lvl2pPr marL="568803" indent="0">
              <a:buNone/>
              <a:defRPr sz="1742"/>
            </a:lvl2pPr>
            <a:lvl3pPr marL="1137605" indent="0">
              <a:buNone/>
              <a:defRPr sz="1493"/>
            </a:lvl3pPr>
            <a:lvl4pPr marL="1706408" indent="0">
              <a:buNone/>
              <a:defRPr sz="1244"/>
            </a:lvl4pPr>
            <a:lvl5pPr marL="2275210" indent="0">
              <a:buNone/>
              <a:defRPr sz="1244"/>
            </a:lvl5pPr>
            <a:lvl6pPr marL="2844013" indent="0">
              <a:buNone/>
              <a:defRPr sz="1244"/>
            </a:lvl6pPr>
            <a:lvl7pPr marL="3412815" indent="0">
              <a:buNone/>
              <a:defRPr sz="1244"/>
            </a:lvl7pPr>
            <a:lvl8pPr marL="3981618" indent="0">
              <a:buNone/>
              <a:defRPr sz="1244"/>
            </a:lvl8pPr>
            <a:lvl9pPr marL="4550420" indent="0">
              <a:buNone/>
              <a:defRPr sz="1244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814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3584" y="648018"/>
            <a:ext cx="3669064" cy="2268061"/>
          </a:xfrm>
        </p:spPr>
        <p:txBody>
          <a:bodyPr anchor="b"/>
          <a:lstStyle>
            <a:lvl1pPr>
              <a:defRPr sz="3981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36292" y="1399540"/>
            <a:ext cx="5759113" cy="6907687"/>
          </a:xfrm>
        </p:spPr>
        <p:txBody>
          <a:bodyPr anchor="t"/>
          <a:lstStyle>
            <a:lvl1pPr marL="0" indent="0">
              <a:buNone/>
              <a:defRPr sz="3981"/>
            </a:lvl1pPr>
            <a:lvl2pPr marL="568803" indent="0">
              <a:buNone/>
              <a:defRPr sz="3483"/>
            </a:lvl2pPr>
            <a:lvl3pPr marL="1137605" indent="0">
              <a:buNone/>
              <a:defRPr sz="2986"/>
            </a:lvl3pPr>
            <a:lvl4pPr marL="1706408" indent="0">
              <a:buNone/>
              <a:defRPr sz="2488"/>
            </a:lvl4pPr>
            <a:lvl5pPr marL="2275210" indent="0">
              <a:buNone/>
              <a:defRPr sz="2488"/>
            </a:lvl5pPr>
            <a:lvl6pPr marL="2844013" indent="0">
              <a:buNone/>
              <a:defRPr sz="2488"/>
            </a:lvl6pPr>
            <a:lvl7pPr marL="3412815" indent="0">
              <a:buNone/>
              <a:defRPr sz="2488"/>
            </a:lvl7pPr>
            <a:lvl8pPr marL="3981618" indent="0">
              <a:buNone/>
              <a:defRPr sz="2488"/>
            </a:lvl8pPr>
            <a:lvl9pPr marL="4550420" indent="0">
              <a:buNone/>
              <a:defRPr sz="2488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3584" y="2916079"/>
            <a:ext cx="3669064" cy="5402397"/>
          </a:xfrm>
        </p:spPr>
        <p:txBody>
          <a:bodyPr/>
          <a:lstStyle>
            <a:lvl1pPr marL="0" indent="0">
              <a:buNone/>
              <a:defRPr sz="1991"/>
            </a:lvl1pPr>
            <a:lvl2pPr marL="568803" indent="0">
              <a:buNone/>
              <a:defRPr sz="1742"/>
            </a:lvl2pPr>
            <a:lvl3pPr marL="1137605" indent="0">
              <a:buNone/>
              <a:defRPr sz="1493"/>
            </a:lvl3pPr>
            <a:lvl4pPr marL="1706408" indent="0">
              <a:buNone/>
              <a:defRPr sz="1244"/>
            </a:lvl4pPr>
            <a:lvl5pPr marL="2275210" indent="0">
              <a:buNone/>
              <a:defRPr sz="1244"/>
            </a:lvl5pPr>
            <a:lvl6pPr marL="2844013" indent="0">
              <a:buNone/>
              <a:defRPr sz="1244"/>
            </a:lvl6pPr>
            <a:lvl7pPr marL="3412815" indent="0">
              <a:buNone/>
              <a:defRPr sz="1244"/>
            </a:lvl7pPr>
            <a:lvl8pPr marL="3981618" indent="0">
              <a:buNone/>
              <a:defRPr sz="1244"/>
            </a:lvl8pPr>
            <a:lvl9pPr marL="4550420" indent="0">
              <a:buNone/>
              <a:defRPr sz="1244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915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82102" y="517516"/>
            <a:ext cx="9811822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102" y="2587570"/>
            <a:ext cx="9811822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82102" y="9009246"/>
            <a:ext cx="2559606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F2380-3690-4A1A-A484-863E4DBABBCD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68309" y="9009246"/>
            <a:ext cx="3839408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034317" y="9009246"/>
            <a:ext cx="2559606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6E432E-9801-4595-B6D7-4F272EECBD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185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137605" rtl="0" eaLnBrk="1" latinLnBrk="0" hangingPunct="1">
        <a:lnSpc>
          <a:spcPct val="90000"/>
        </a:lnSpc>
        <a:spcBef>
          <a:spcPct val="0"/>
        </a:spcBef>
        <a:buNone/>
        <a:defRPr sz="54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4401" indent="-284401" algn="l" defTabSz="1137605" rtl="0" eaLnBrk="1" latinLnBrk="0" hangingPunct="1">
        <a:lnSpc>
          <a:spcPct val="90000"/>
        </a:lnSpc>
        <a:spcBef>
          <a:spcPts val="1244"/>
        </a:spcBef>
        <a:buFont typeface="Arial" panose="020B0604020202020204" pitchFamily="34" charset="0"/>
        <a:buChar char="•"/>
        <a:defRPr sz="3483" kern="1200">
          <a:solidFill>
            <a:schemeClr val="tx1"/>
          </a:solidFill>
          <a:latin typeface="+mn-lt"/>
          <a:ea typeface="+mn-ea"/>
          <a:cs typeface="+mn-cs"/>
        </a:defRPr>
      </a:lvl1pPr>
      <a:lvl2pPr marL="853204" indent="-284401" algn="l" defTabSz="1137605" rtl="0" eaLnBrk="1" latinLnBrk="0" hangingPunct="1">
        <a:lnSpc>
          <a:spcPct val="90000"/>
        </a:lnSpc>
        <a:spcBef>
          <a:spcPts val="622"/>
        </a:spcBef>
        <a:buFont typeface="Arial" panose="020B0604020202020204" pitchFamily="34" charset="0"/>
        <a:buChar char="•"/>
        <a:defRPr sz="2986" kern="1200">
          <a:solidFill>
            <a:schemeClr val="tx1"/>
          </a:solidFill>
          <a:latin typeface="+mn-lt"/>
          <a:ea typeface="+mn-ea"/>
          <a:cs typeface="+mn-cs"/>
        </a:defRPr>
      </a:lvl2pPr>
      <a:lvl3pPr marL="1422006" indent="-284401" algn="l" defTabSz="1137605" rtl="0" eaLnBrk="1" latinLnBrk="0" hangingPunct="1">
        <a:lnSpc>
          <a:spcPct val="90000"/>
        </a:lnSpc>
        <a:spcBef>
          <a:spcPts val="622"/>
        </a:spcBef>
        <a:buFont typeface="Arial" panose="020B0604020202020204" pitchFamily="34" charset="0"/>
        <a:buChar char="•"/>
        <a:defRPr sz="2488" kern="1200">
          <a:solidFill>
            <a:schemeClr val="tx1"/>
          </a:solidFill>
          <a:latin typeface="+mn-lt"/>
          <a:ea typeface="+mn-ea"/>
          <a:cs typeface="+mn-cs"/>
        </a:defRPr>
      </a:lvl3pPr>
      <a:lvl4pPr marL="1990809" indent="-284401" algn="l" defTabSz="1137605" rtl="0" eaLnBrk="1" latinLnBrk="0" hangingPunct="1">
        <a:lnSpc>
          <a:spcPct val="90000"/>
        </a:lnSpc>
        <a:spcBef>
          <a:spcPts val="622"/>
        </a:spcBef>
        <a:buFont typeface="Arial" panose="020B0604020202020204" pitchFamily="34" charset="0"/>
        <a:buChar char="•"/>
        <a:defRPr sz="2239" kern="1200">
          <a:solidFill>
            <a:schemeClr val="tx1"/>
          </a:solidFill>
          <a:latin typeface="+mn-lt"/>
          <a:ea typeface="+mn-ea"/>
          <a:cs typeface="+mn-cs"/>
        </a:defRPr>
      </a:lvl4pPr>
      <a:lvl5pPr marL="2559611" indent="-284401" algn="l" defTabSz="1137605" rtl="0" eaLnBrk="1" latinLnBrk="0" hangingPunct="1">
        <a:lnSpc>
          <a:spcPct val="90000"/>
        </a:lnSpc>
        <a:spcBef>
          <a:spcPts val="622"/>
        </a:spcBef>
        <a:buFont typeface="Arial" panose="020B0604020202020204" pitchFamily="34" charset="0"/>
        <a:buChar char="•"/>
        <a:defRPr sz="2239" kern="1200">
          <a:solidFill>
            <a:schemeClr val="tx1"/>
          </a:solidFill>
          <a:latin typeface="+mn-lt"/>
          <a:ea typeface="+mn-ea"/>
          <a:cs typeface="+mn-cs"/>
        </a:defRPr>
      </a:lvl5pPr>
      <a:lvl6pPr marL="3128414" indent="-284401" algn="l" defTabSz="1137605" rtl="0" eaLnBrk="1" latinLnBrk="0" hangingPunct="1">
        <a:lnSpc>
          <a:spcPct val="90000"/>
        </a:lnSpc>
        <a:spcBef>
          <a:spcPts val="622"/>
        </a:spcBef>
        <a:buFont typeface="Arial" panose="020B0604020202020204" pitchFamily="34" charset="0"/>
        <a:buChar char="•"/>
        <a:defRPr sz="2239" kern="1200">
          <a:solidFill>
            <a:schemeClr val="tx1"/>
          </a:solidFill>
          <a:latin typeface="+mn-lt"/>
          <a:ea typeface="+mn-ea"/>
          <a:cs typeface="+mn-cs"/>
        </a:defRPr>
      </a:lvl6pPr>
      <a:lvl7pPr marL="3697216" indent="-284401" algn="l" defTabSz="1137605" rtl="0" eaLnBrk="1" latinLnBrk="0" hangingPunct="1">
        <a:lnSpc>
          <a:spcPct val="90000"/>
        </a:lnSpc>
        <a:spcBef>
          <a:spcPts val="622"/>
        </a:spcBef>
        <a:buFont typeface="Arial" panose="020B0604020202020204" pitchFamily="34" charset="0"/>
        <a:buChar char="•"/>
        <a:defRPr sz="2239" kern="1200">
          <a:solidFill>
            <a:schemeClr val="tx1"/>
          </a:solidFill>
          <a:latin typeface="+mn-lt"/>
          <a:ea typeface="+mn-ea"/>
          <a:cs typeface="+mn-cs"/>
        </a:defRPr>
      </a:lvl7pPr>
      <a:lvl8pPr marL="4266019" indent="-284401" algn="l" defTabSz="1137605" rtl="0" eaLnBrk="1" latinLnBrk="0" hangingPunct="1">
        <a:lnSpc>
          <a:spcPct val="90000"/>
        </a:lnSpc>
        <a:spcBef>
          <a:spcPts val="622"/>
        </a:spcBef>
        <a:buFont typeface="Arial" panose="020B0604020202020204" pitchFamily="34" charset="0"/>
        <a:buChar char="•"/>
        <a:defRPr sz="2239" kern="1200">
          <a:solidFill>
            <a:schemeClr val="tx1"/>
          </a:solidFill>
          <a:latin typeface="+mn-lt"/>
          <a:ea typeface="+mn-ea"/>
          <a:cs typeface="+mn-cs"/>
        </a:defRPr>
      </a:lvl8pPr>
      <a:lvl9pPr marL="4834821" indent="-284401" algn="l" defTabSz="1137605" rtl="0" eaLnBrk="1" latinLnBrk="0" hangingPunct="1">
        <a:lnSpc>
          <a:spcPct val="90000"/>
        </a:lnSpc>
        <a:spcBef>
          <a:spcPts val="622"/>
        </a:spcBef>
        <a:buFont typeface="Arial" panose="020B0604020202020204" pitchFamily="34" charset="0"/>
        <a:buChar char="•"/>
        <a:defRPr sz="22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1pPr>
      <a:lvl2pPr marL="568803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2pPr>
      <a:lvl3pPr marL="1137605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3pPr>
      <a:lvl4pPr marL="1706408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4pPr>
      <a:lvl5pPr marL="2275210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5pPr>
      <a:lvl6pPr marL="2844013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6pPr>
      <a:lvl7pPr marL="3412815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7pPr>
      <a:lvl8pPr marL="3981618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8pPr>
      <a:lvl9pPr marL="4550420" algn="l" defTabSz="1137605" rtl="0" eaLnBrk="1" latinLnBrk="0" hangingPunct="1">
        <a:defRPr sz="22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01156" y="77144"/>
            <a:ext cx="1322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 Fig.S1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0" y="363826"/>
            <a:ext cx="100556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A)                                                                                                                                                                                                                            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oup 5">
            <a:extLst>
              <a:ext uri="{FF2B5EF4-FFF2-40B4-BE49-F238E27FC236}">
                <a16:creationId xmlns:a16="http://schemas.microsoft.com/office/drawing/2014/main" id="{4A34DB38-7B09-4CB3-B73C-44B94C3FD154}"/>
              </a:ext>
            </a:extLst>
          </p:cNvPr>
          <p:cNvGrpSpPr/>
          <p:nvPr/>
        </p:nvGrpSpPr>
        <p:grpSpPr>
          <a:xfrm>
            <a:off x="201157" y="240165"/>
            <a:ext cx="10981194" cy="2468530"/>
            <a:chOff x="-16828" y="4751800"/>
            <a:chExt cx="12225658" cy="2040008"/>
          </a:xfrm>
        </p:grpSpPr>
        <p:pic>
          <p:nvPicPr>
            <p:cNvPr id="35" name="Picture 16">
              <a:extLst>
                <a:ext uri="{FF2B5EF4-FFF2-40B4-BE49-F238E27FC236}">
                  <a16:creationId xmlns:a16="http://schemas.microsoft.com/office/drawing/2014/main" id="{0152F97A-5B1F-46C3-B0D2-64949A6CAA9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466" t="7475" r="20907" b="3791"/>
            <a:stretch/>
          </p:blipFill>
          <p:spPr bwMode="auto">
            <a:xfrm rot="5400000">
              <a:off x="5075997" y="-341025"/>
              <a:ext cx="2040008" cy="122256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6" name="Picture 18">
              <a:extLst>
                <a:ext uri="{FF2B5EF4-FFF2-40B4-BE49-F238E27FC236}">
                  <a16:creationId xmlns:a16="http://schemas.microsoft.com/office/drawing/2014/main" id="{93C77A09-A465-410F-B5B8-9BEA87AD869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1" t="-962" r="-651" b="97658"/>
            <a:stretch/>
          </p:blipFill>
          <p:spPr bwMode="auto">
            <a:xfrm>
              <a:off x="147295" y="5017813"/>
              <a:ext cx="1850318" cy="33259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2" name="Imag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156604"/>
            <a:ext cx="10833777" cy="7435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53407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6">
            <a:extLst>
              <a:ext uri="{FF2B5EF4-FFF2-40B4-BE49-F238E27FC236}">
                <a16:creationId xmlns:a16="http://schemas.microsoft.com/office/drawing/2014/main" id="{EF73F1C1-D485-BF9B-E619-AA61C478E3B2}"/>
              </a:ext>
            </a:extLst>
          </p:cNvPr>
          <p:cNvSpPr txBox="1"/>
          <p:nvPr/>
        </p:nvSpPr>
        <p:spPr>
          <a:xfrm>
            <a:off x="0" y="427994"/>
            <a:ext cx="100556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C)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3">
            <a:extLst>
              <a:ext uri="{FF2B5EF4-FFF2-40B4-BE49-F238E27FC236}">
                <a16:creationId xmlns:a16="http://schemas.microsoft.com/office/drawing/2014/main" id="{DC02578F-2065-36B4-20D9-3244473D5359}"/>
              </a:ext>
            </a:extLst>
          </p:cNvPr>
          <p:cNvSpPr txBox="1"/>
          <p:nvPr/>
        </p:nvSpPr>
        <p:spPr>
          <a:xfrm>
            <a:off x="201156" y="141312"/>
            <a:ext cx="12426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 Fig.S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95BF33A-11D4-3D99-5442-27DB0BA5D3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2471" y="551104"/>
            <a:ext cx="8701091" cy="89705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33581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01156" y="1000552"/>
            <a:ext cx="10719886" cy="6694209"/>
            <a:chOff x="0" y="636295"/>
            <a:chExt cx="11541994" cy="6737150"/>
          </a:xfrm>
        </p:grpSpPr>
        <p:grpSp>
          <p:nvGrpSpPr>
            <p:cNvPr id="3" name="Groupe 2"/>
            <p:cNvGrpSpPr/>
            <p:nvPr/>
          </p:nvGrpSpPr>
          <p:grpSpPr>
            <a:xfrm>
              <a:off x="0" y="636295"/>
              <a:ext cx="11270512" cy="3180594"/>
              <a:chOff x="0" y="498271"/>
              <a:chExt cx="11288500" cy="2454480"/>
            </a:xfrm>
          </p:grpSpPr>
          <p:sp>
            <p:nvSpPr>
              <p:cNvPr id="11" name="ZoneTexte 10"/>
              <p:cNvSpPr txBox="1"/>
              <p:nvPr/>
            </p:nvSpPr>
            <p:spPr>
              <a:xfrm>
                <a:off x="0" y="498271"/>
                <a:ext cx="10055658" cy="1912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                                                                                        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" name="Groupe 11"/>
              <p:cNvGrpSpPr/>
              <p:nvPr/>
            </p:nvGrpSpPr>
            <p:grpSpPr>
              <a:xfrm>
                <a:off x="148877" y="809037"/>
                <a:ext cx="11139623" cy="2143714"/>
                <a:chOff x="148877" y="809037"/>
                <a:chExt cx="11139623" cy="2143714"/>
              </a:xfrm>
            </p:grpSpPr>
            <p:grpSp>
              <p:nvGrpSpPr>
                <p:cNvPr id="13" name="Groupe 12"/>
                <p:cNvGrpSpPr/>
                <p:nvPr/>
              </p:nvGrpSpPr>
              <p:grpSpPr>
                <a:xfrm>
                  <a:off x="148877" y="809037"/>
                  <a:ext cx="11139623" cy="2143714"/>
                  <a:chOff x="148877" y="809037"/>
                  <a:chExt cx="11139623" cy="2143714"/>
                </a:xfrm>
              </p:grpSpPr>
              <p:grpSp>
                <p:nvGrpSpPr>
                  <p:cNvPr id="15" name="Group 6">
                    <a:extLst>
                      <a:ext uri="{FF2B5EF4-FFF2-40B4-BE49-F238E27FC236}">
                        <a16:creationId xmlns:a16="http://schemas.microsoft.com/office/drawing/2014/main" id="{24F8E2F6-FD21-4CA6-A6CF-8A3BDFFD6141}"/>
                      </a:ext>
                    </a:extLst>
                  </p:cNvPr>
                  <p:cNvGrpSpPr/>
                  <p:nvPr/>
                </p:nvGrpSpPr>
                <p:grpSpPr>
                  <a:xfrm>
                    <a:off x="148877" y="837782"/>
                    <a:ext cx="3176105" cy="2105811"/>
                    <a:chOff x="331500" y="400425"/>
                    <a:chExt cx="3873875" cy="2454428"/>
                  </a:xfrm>
                </p:grpSpPr>
                <p:pic>
                  <p:nvPicPr>
                    <p:cNvPr id="18" name="Picture 7">
                      <a:extLst>
                        <a:ext uri="{FF2B5EF4-FFF2-40B4-BE49-F238E27FC236}">
                          <a16:creationId xmlns:a16="http://schemas.microsoft.com/office/drawing/2014/main" id="{F1393E8F-5A4B-4990-B780-A461568F991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331500" y="400425"/>
                      <a:ext cx="3873875" cy="2255167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9" name="TextBox 8">
                      <a:extLst>
                        <a:ext uri="{FF2B5EF4-FFF2-40B4-BE49-F238E27FC236}">
                          <a16:creationId xmlns:a16="http://schemas.microsoft.com/office/drawing/2014/main" id="{99B90B99-0E03-48D7-BCFF-D20BF6508B2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14705" y="2567870"/>
                      <a:ext cx="1734629" cy="28698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log10 (FDR q value)</a:t>
                      </a:r>
                    </a:p>
                  </p:txBody>
                </p:sp>
              </p:grpSp>
              <p:pic>
                <p:nvPicPr>
                  <p:cNvPr id="16" name="Picture 9">
                    <a:extLst>
                      <a:ext uri="{FF2B5EF4-FFF2-40B4-BE49-F238E27FC236}">
                        <a16:creationId xmlns:a16="http://schemas.microsoft.com/office/drawing/2014/main" id="{99634083-EEE7-4244-9085-55A48982065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6751519" y="809037"/>
                    <a:ext cx="4536981" cy="2143714"/>
                  </a:xfrm>
                  <a:prstGeom prst="rect">
                    <a:avLst/>
                  </a:prstGeom>
                </p:spPr>
              </p:pic>
              <p:pic>
                <p:nvPicPr>
                  <p:cNvPr id="17" name="Picture 5">
                    <a:extLst>
                      <a:ext uri="{FF2B5EF4-FFF2-40B4-BE49-F238E27FC236}">
                        <a16:creationId xmlns:a16="http://schemas.microsoft.com/office/drawing/2014/main" id="{04549316-A590-443D-8BE8-D83F9DD1131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3732340" y="837782"/>
                    <a:ext cx="2688733" cy="1530664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4" name="TextBox 8">
                  <a:extLst>
                    <a:ext uri="{FF2B5EF4-FFF2-40B4-BE49-F238E27FC236}">
                      <a16:creationId xmlns:a16="http://schemas.microsoft.com/office/drawing/2014/main" id="{99B90B99-0E03-48D7-BCFF-D20BF6508B27}"/>
                    </a:ext>
                  </a:extLst>
                </p:cNvPr>
                <p:cNvSpPr txBox="1"/>
                <p:nvPr/>
              </p:nvSpPr>
              <p:spPr>
                <a:xfrm>
                  <a:off x="9294479" y="2699872"/>
                  <a:ext cx="1422184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log10 (FDR q value)</a:t>
                  </a:r>
                </a:p>
              </p:txBody>
            </p:sp>
          </p:grpSp>
        </p:grpSp>
        <p:grpSp>
          <p:nvGrpSpPr>
            <p:cNvPr id="4" name="Groupe 3"/>
            <p:cNvGrpSpPr/>
            <p:nvPr/>
          </p:nvGrpSpPr>
          <p:grpSpPr>
            <a:xfrm>
              <a:off x="148640" y="3900529"/>
              <a:ext cx="11393354" cy="3472916"/>
              <a:chOff x="2500" y="3303931"/>
              <a:chExt cx="11393354" cy="2867542"/>
            </a:xfrm>
          </p:grpSpPr>
          <p:pic>
            <p:nvPicPr>
              <p:cNvPr id="5" name="Picture 12">
                <a:extLst>
                  <a:ext uri="{FF2B5EF4-FFF2-40B4-BE49-F238E27FC236}">
                    <a16:creationId xmlns:a16="http://schemas.microsoft.com/office/drawing/2014/main" id="{5CAA610B-AD65-4864-A9AD-4EE0B6365C2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859854" y="3974068"/>
                <a:ext cx="4536000" cy="2145600"/>
              </a:xfrm>
              <a:prstGeom prst="rect">
                <a:avLst/>
              </a:prstGeom>
            </p:spPr>
          </p:pic>
          <p:pic>
            <p:nvPicPr>
              <p:cNvPr id="6" name="Picture 10">
                <a:extLst>
                  <a:ext uri="{FF2B5EF4-FFF2-40B4-BE49-F238E27FC236}">
                    <a16:creationId xmlns:a16="http://schemas.microsoft.com/office/drawing/2014/main" id="{9D7F31FF-9ABB-43F1-94CE-C878BAAA286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732340" y="4077660"/>
                <a:ext cx="2689200" cy="1530000"/>
              </a:xfrm>
              <a:prstGeom prst="rect">
                <a:avLst/>
              </a:prstGeom>
            </p:spPr>
          </p:pic>
          <p:pic>
            <p:nvPicPr>
              <p:cNvPr id="7" name="Picture 13">
                <a:extLst>
                  <a:ext uri="{FF2B5EF4-FFF2-40B4-BE49-F238E27FC236}">
                    <a16:creationId xmlns:a16="http://schemas.microsoft.com/office/drawing/2014/main" id="{B42B16D1-DE61-4E41-8BDB-77B970E87F3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03835" y="4067542"/>
                <a:ext cx="3175200" cy="1936800"/>
              </a:xfrm>
              <a:prstGeom prst="rect">
                <a:avLst/>
              </a:prstGeom>
            </p:spPr>
          </p:pic>
          <p:sp>
            <p:nvSpPr>
              <p:cNvPr id="8" name="ZoneTexte 7"/>
              <p:cNvSpPr txBox="1"/>
              <p:nvPr/>
            </p:nvSpPr>
            <p:spPr>
              <a:xfrm>
                <a:off x="2500" y="3303931"/>
                <a:ext cx="10055658" cy="2046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                                                                                        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9B90B99-0E03-48D7-BCFF-D20BF6508B27}"/>
                  </a:ext>
                </a:extLst>
              </p:cNvPr>
              <p:cNvSpPr txBox="1"/>
              <p:nvPr/>
            </p:nvSpPr>
            <p:spPr>
              <a:xfrm>
                <a:off x="9446879" y="5925252"/>
                <a:ext cx="142218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log10 (FDR q value)</a:t>
                </a:r>
              </a:p>
            </p:txBody>
          </p:sp>
          <p:sp>
            <p:nvSpPr>
              <p:cNvPr id="10" name="TextBox 8">
                <a:extLst>
                  <a:ext uri="{FF2B5EF4-FFF2-40B4-BE49-F238E27FC236}">
                    <a16:creationId xmlns:a16="http://schemas.microsoft.com/office/drawing/2014/main" id="{99B90B99-0E03-48D7-BCFF-D20BF6508B27}"/>
                  </a:ext>
                </a:extLst>
              </p:cNvPr>
              <p:cNvSpPr txBox="1"/>
              <p:nvPr/>
            </p:nvSpPr>
            <p:spPr>
              <a:xfrm>
                <a:off x="1849365" y="5837812"/>
                <a:ext cx="142218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log10 (FDR q value)</a:t>
                </a:r>
              </a:p>
            </p:txBody>
          </p:sp>
        </p:grpSp>
      </p:grpSp>
      <p:sp>
        <p:nvSpPr>
          <p:cNvPr id="20" name="ZoneTexte 3">
            <a:extLst>
              <a:ext uri="{FF2B5EF4-FFF2-40B4-BE49-F238E27FC236}">
                <a16:creationId xmlns:a16="http://schemas.microsoft.com/office/drawing/2014/main" id="{DC02578F-2065-36B4-20D9-3244473D5359}"/>
              </a:ext>
            </a:extLst>
          </p:cNvPr>
          <p:cNvSpPr txBox="1"/>
          <p:nvPr/>
        </p:nvSpPr>
        <p:spPr>
          <a:xfrm>
            <a:off x="201156" y="141312"/>
            <a:ext cx="1650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 Fig.S2</a:t>
            </a:r>
          </a:p>
        </p:txBody>
      </p:sp>
    </p:spTree>
    <p:extLst>
      <p:ext uri="{BB962C8B-B14F-4D97-AF65-F5344CB8AC3E}">
        <p14:creationId xmlns:p14="http://schemas.microsoft.com/office/powerpoint/2010/main" val="36448138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55</TotalTime>
  <Words>52</Words>
  <Application>Microsoft Office PowerPoint</Application>
  <PresentationFormat>Custom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m</dc:creator>
  <cp:lastModifiedBy>MDPI</cp:lastModifiedBy>
  <cp:revision>791</cp:revision>
  <cp:lastPrinted>2020-09-07T05:29:07Z</cp:lastPrinted>
  <dcterms:created xsi:type="dcterms:W3CDTF">2018-01-09T01:24:50Z</dcterms:created>
  <dcterms:modified xsi:type="dcterms:W3CDTF">2022-06-30T20:25:23Z</dcterms:modified>
</cp:coreProperties>
</file>